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315200" cy="10058400"/>
  <p:notesSz cx="7077075" cy="91186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E87251-E8A0-43C0-AB97-EA8A1493D21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65040" y="402840"/>
            <a:ext cx="658512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65040" y="2346120"/>
            <a:ext cx="658512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65040" y="5814000"/>
            <a:ext cx="658512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EEE103-51BD-4D05-95D4-5A2992C628B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65040" y="402840"/>
            <a:ext cx="658512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65040" y="2346120"/>
            <a:ext cx="32133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739320" y="2346120"/>
            <a:ext cx="32133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65040" y="5814000"/>
            <a:ext cx="32133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739320" y="5814000"/>
            <a:ext cx="32133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79E986-1EBF-48C1-97F2-6A11A54C3E8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65040" y="402840"/>
            <a:ext cx="658512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65040" y="2346120"/>
            <a:ext cx="212004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591640" y="2346120"/>
            <a:ext cx="212004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817880" y="2346120"/>
            <a:ext cx="212004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65040" y="5814000"/>
            <a:ext cx="212004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591640" y="5814000"/>
            <a:ext cx="212004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817880" y="5814000"/>
            <a:ext cx="212004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9E8761-F164-49DE-9202-B717488F230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65040" y="402840"/>
            <a:ext cx="658512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65040" y="2346120"/>
            <a:ext cx="6585120" cy="6638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444534-44EA-4CD5-A854-E68D9573579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65040" y="402840"/>
            <a:ext cx="658512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65040" y="2346120"/>
            <a:ext cx="6585120" cy="663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09E81E-3664-44BB-BB45-1413C6EDC52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65040" y="402840"/>
            <a:ext cx="658512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65040" y="2346120"/>
            <a:ext cx="3213360" cy="663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739320" y="2346120"/>
            <a:ext cx="3213360" cy="663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1AEC7D-9C04-46FB-83B3-42DDB50D683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65040" y="402840"/>
            <a:ext cx="658512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FDEB9F-C012-4F4E-A521-A0C53A592BB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65040" y="402840"/>
            <a:ext cx="6585120" cy="7772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9CF3ED-3A16-44C2-B15E-3EAFF62A928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65040" y="402840"/>
            <a:ext cx="658512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65040" y="2346120"/>
            <a:ext cx="32133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739320" y="2346120"/>
            <a:ext cx="3213360" cy="663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65040" y="5814000"/>
            <a:ext cx="32133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4C2531-5AC6-4F7C-8E39-D90DA63713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65040" y="402840"/>
            <a:ext cx="658512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65040" y="2346120"/>
            <a:ext cx="3213360" cy="663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739320" y="2346120"/>
            <a:ext cx="32133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739320" y="5814000"/>
            <a:ext cx="32133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590EF2-1414-4499-911A-ADC8B0895D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65040" y="402840"/>
            <a:ext cx="658512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65040" y="2346120"/>
            <a:ext cx="32133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739320" y="2346120"/>
            <a:ext cx="32133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65040" y="5814000"/>
            <a:ext cx="658512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321EA5-C716-4AF6-95DA-4C8A7BF46C5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65040" y="402840"/>
            <a:ext cx="658512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65040" y="2346120"/>
            <a:ext cx="6585120" cy="663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64680" y="9159840"/>
            <a:ext cx="1708200" cy="698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498760" y="9159840"/>
            <a:ext cx="2317680" cy="698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241600" y="9159840"/>
            <a:ext cx="1708200" cy="698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22202BE-10FB-4BFA-8C09-452450EF51F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5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055520" y="671400"/>
            <a:ext cx="5171040" cy="8145720"/>
            <a:chOff x="1055520" y="671400"/>
            <a:chExt cx="5171040" cy="8145720"/>
          </a:xfrm>
        </p:grpSpPr>
        <p:pic>
          <p:nvPicPr>
            <p:cNvPr id="42" name="" descr=""/>
            <p:cNvPicPr/>
            <p:nvPr/>
          </p:nvPicPr>
          <p:blipFill>
            <a:blip r:embed="rId1"/>
            <a:stretch/>
          </p:blipFill>
          <p:spPr>
            <a:xfrm>
              <a:off x="3897360" y="671400"/>
              <a:ext cx="2286000" cy="2743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"/>
            <p:cNvSpPr/>
            <p:nvPr/>
          </p:nvSpPr>
          <p:spPr>
            <a:xfrm>
              <a:off x="4278960" y="955800"/>
              <a:ext cx="659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Polymeras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4" name="" descr=""/>
            <p:cNvPicPr/>
            <p:nvPr/>
          </p:nvPicPr>
          <p:blipFill>
            <a:blip r:embed="rId2"/>
            <a:stretch/>
          </p:blipFill>
          <p:spPr>
            <a:xfrm>
              <a:off x="1055520" y="3378240"/>
              <a:ext cx="2286000" cy="2741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5" name=""/>
            <p:cNvSpPr/>
            <p:nvPr/>
          </p:nvSpPr>
          <p:spPr>
            <a:xfrm>
              <a:off x="1433160" y="3676680"/>
              <a:ext cx="467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Pento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6" name="" descr=""/>
            <p:cNvPicPr/>
            <p:nvPr/>
          </p:nvPicPr>
          <p:blipFill>
            <a:blip r:embed="rId3"/>
            <a:stretch/>
          </p:blipFill>
          <p:spPr>
            <a:xfrm>
              <a:off x="1057320" y="6073920"/>
              <a:ext cx="2286000" cy="2743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7" name=""/>
            <p:cNvSpPr/>
            <p:nvPr/>
          </p:nvSpPr>
          <p:spPr>
            <a:xfrm>
              <a:off x="1437840" y="6372360"/>
              <a:ext cx="528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Proteas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8" name="" descr=""/>
            <p:cNvPicPr/>
            <p:nvPr/>
          </p:nvPicPr>
          <p:blipFill>
            <a:blip r:embed="rId4"/>
            <a:stretch/>
          </p:blipFill>
          <p:spPr>
            <a:xfrm>
              <a:off x="1058760" y="673200"/>
              <a:ext cx="2286000" cy="2743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9" name=""/>
            <p:cNvSpPr/>
            <p:nvPr/>
          </p:nvSpPr>
          <p:spPr>
            <a:xfrm>
              <a:off x="1439640" y="970200"/>
              <a:ext cx="1082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DNA Binding Prote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0" name="" descr=""/>
            <p:cNvPicPr/>
            <p:nvPr/>
          </p:nvPicPr>
          <p:blipFill>
            <a:blip r:embed="rId5"/>
            <a:stretch/>
          </p:blipFill>
          <p:spPr>
            <a:xfrm>
              <a:off x="3895560" y="3375000"/>
              <a:ext cx="2286000" cy="2741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1" name=""/>
            <p:cNvSpPr/>
            <p:nvPr/>
          </p:nvSpPr>
          <p:spPr>
            <a:xfrm>
              <a:off x="4279320" y="3670200"/>
              <a:ext cx="455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Hexo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2" name="" descr=""/>
            <p:cNvPicPr/>
            <p:nvPr/>
          </p:nvPicPr>
          <p:blipFill>
            <a:blip r:embed="rId6"/>
            <a:stretch/>
          </p:blipFill>
          <p:spPr>
            <a:xfrm>
              <a:off x="3897360" y="6072120"/>
              <a:ext cx="2286000" cy="2743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3" name=""/>
            <p:cNvSpPr/>
            <p:nvPr/>
          </p:nvSpPr>
          <p:spPr>
            <a:xfrm>
              <a:off x="4282200" y="6372360"/>
              <a:ext cx="406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pVII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1069560" y="685800"/>
              <a:ext cx="328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A.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3879720" y="684360"/>
              <a:ext cx="320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B.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1061640" y="3368880"/>
              <a:ext cx="328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C.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3881160" y="3365640"/>
              <a:ext cx="328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D.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3881880" y="6080040"/>
              <a:ext cx="311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F.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1056960" y="6085080"/>
              <a:ext cx="320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E.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2547720" y="1629000"/>
              <a:ext cx="266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2666880" y="1838520"/>
              <a:ext cx="266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2562120" y="2067120"/>
              <a:ext cx="266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2352600" y="2600280"/>
              <a:ext cx="266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2147760" y="3024360"/>
              <a:ext cx="266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2952720" y="2314800"/>
              <a:ext cx="0" cy="266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 flipV="1">
              <a:off x="2957400" y="2691000"/>
              <a:ext cx="0" cy="266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2089440" y="1513080"/>
              <a:ext cx="53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HAdV-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2217960" y="1717560"/>
              <a:ext cx="53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HAdV-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2103480" y="1946160"/>
              <a:ext cx="53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HAdV-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1846080" y="2479680"/>
              <a:ext cx="589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HAdV-1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2655720" y="2141640"/>
              <a:ext cx="589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HAdV-3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1636560" y="2903760"/>
              <a:ext cx="589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HAdV-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2670480" y="2913120"/>
              <a:ext cx="53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HAdV-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 flipV="1">
              <a:off x="5205960" y="1091520"/>
              <a:ext cx="188640" cy="188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 flipV="1">
              <a:off x="5353560" y="1201320"/>
              <a:ext cx="188640" cy="188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 flipH="1" flipV="1">
              <a:off x="5730120" y="1172520"/>
              <a:ext cx="188640" cy="188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4967280" y="2243160"/>
              <a:ext cx="266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 flipH="1">
              <a:off x="5319360" y="2243160"/>
              <a:ext cx="266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4971960" y="2824200"/>
              <a:ext cx="266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 flipH="1">
              <a:off x="5328720" y="3276720"/>
              <a:ext cx="266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4813560" y="1217520"/>
              <a:ext cx="53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HAdV-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4960800" y="1336680"/>
              <a:ext cx="589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HAdV-1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5594400" y="1317600"/>
              <a:ext cx="589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HAdV-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4503960" y="2122560"/>
              <a:ext cx="53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HAdV-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5513400" y="2127240"/>
              <a:ext cx="589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HAdV-3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4508640" y="2703600"/>
              <a:ext cx="53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HAdV-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5527800" y="3160800"/>
              <a:ext cx="53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HAdV-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1876320" y="4081680"/>
              <a:ext cx="266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 flipH="1">
              <a:off x="2271240" y="4381560"/>
              <a:ext cx="266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 flipH="1">
              <a:off x="2171160" y="4824360"/>
              <a:ext cx="266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 flipH="1">
              <a:off x="2299680" y="5214960"/>
              <a:ext cx="266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1904760" y="5167440"/>
              <a:ext cx="266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2043000" y="5586480"/>
              <a:ext cx="266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 flipH="1">
              <a:off x="2480760" y="5715000"/>
              <a:ext cx="266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2470320" y="4270320"/>
              <a:ext cx="53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HAdV-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2365560" y="4713480"/>
              <a:ext cx="53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HAdV-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2489040" y="5103720"/>
              <a:ext cx="589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HAdV-3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1446480" y="5051520"/>
              <a:ext cx="53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HAdV-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1527120" y="5470560"/>
              <a:ext cx="589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HAdV-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2674800" y="5608800"/>
              <a:ext cx="589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HAdV-1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1417680" y="3960720"/>
              <a:ext cx="53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HAdV-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 flipH="1">
              <a:off x="4986360" y="3867120"/>
              <a:ext cx="2664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 flipH="1">
              <a:off x="5157360" y="4424400"/>
              <a:ext cx="266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4695840" y="4548240"/>
              <a:ext cx="266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 flipV="1">
              <a:off x="4810680" y="4696920"/>
              <a:ext cx="188640" cy="188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 flipH="1">
              <a:off x="5085720" y="4757760"/>
              <a:ext cx="266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 flipH="1">
              <a:off x="5195520" y="5091120"/>
              <a:ext cx="266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4824360" y="5319720"/>
              <a:ext cx="266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5180400" y="3756240"/>
              <a:ext cx="53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HAdV-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5346720" y="4313160"/>
              <a:ext cx="589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HAdV-3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4237200" y="4432320"/>
              <a:ext cx="53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HAdV-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5280120" y="4646520"/>
              <a:ext cx="53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HAdV-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4508640" y="4837320"/>
              <a:ext cx="53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HAdV-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5384520" y="4979880"/>
              <a:ext cx="589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HAdV-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4322520" y="5199120"/>
              <a:ext cx="589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HAdV-1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5039640" y="6801840"/>
              <a:ext cx="188640" cy="188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 flipV="1">
              <a:off x="5063040" y="7073280"/>
              <a:ext cx="188640" cy="188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 flipV="1">
              <a:off x="6024600" y="7090920"/>
              <a:ext cx="0" cy="266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 flipV="1">
              <a:off x="5644080" y="7087680"/>
              <a:ext cx="188640" cy="188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6000480" y="6629400"/>
              <a:ext cx="0" cy="266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5572800" y="6701760"/>
              <a:ext cx="188640" cy="188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4737240" y="6637320"/>
              <a:ext cx="53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HAdV-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4761000" y="7213680"/>
              <a:ext cx="53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HAdV-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5151600" y="6699240"/>
              <a:ext cx="53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HAdV-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5194080" y="6542280"/>
              <a:ext cx="589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HAdV-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5637240" y="6456600"/>
              <a:ext cx="589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HAdV-1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5341680" y="7228080"/>
              <a:ext cx="589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HAdV-3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5492160" y="6863760"/>
              <a:ext cx="188640" cy="188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5685120" y="7318440"/>
              <a:ext cx="53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HAdV-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6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1-16T22:22:56Z</dcterms:created>
  <dc:creator>achintak</dc:creator>
  <dc:description/>
  <dc:language>en-US</dc:language>
  <cp:lastModifiedBy>Chris Robinson</cp:lastModifiedBy>
  <dcterms:modified xsi:type="dcterms:W3CDTF">2008-04-03T21:57:53Z</dcterms:modified>
  <cp:revision>122</cp:revision>
  <dc:subject/>
  <dc:title>Slide 1</dc:title>
</cp:coreProperties>
</file>